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3EA247-C38D-525B-7B73-6BA55854A810}" v="8" dt="2024-01-21T19:56:55.7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52" d="100"/>
          <a:sy n="52" d="100"/>
        </p:scale>
        <p:origin x="2506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Hundley, Heather Ann" userId="9923bbf4-35ca-4515-b4c1-83653bfb90e1" providerId="ADAL" clId="{66347C9E-B753-7C41-9631-0F3A776E72D4}"/>
    <pc:docChg chg="modSld">
      <pc:chgData name="Hundley, Heather Ann" userId="9923bbf4-35ca-4515-b4c1-83653bfb90e1" providerId="ADAL" clId="{66347C9E-B753-7C41-9631-0F3A776E72D4}" dt="2023-08-02T14:20:25.801" v="3" actId="20577"/>
      <pc:docMkLst>
        <pc:docMk/>
      </pc:docMkLst>
      <pc:sldChg chg="modSp mod">
        <pc:chgData name="Hundley, Heather Ann" userId="9923bbf4-35ca-4515-b4c1-83653bfb90e1" providerId="ADAL" clId="{66347C9E-B753-7C41-9631-0F3A776E72D4}" dt="2023-08-02T14:20:25.801" v="3" actId="20577"/>
        <pc:sldMkLst>
          <pc:docMk/>
          <pc:sldMk cId="288543358" sldId="258"/>
        </pc:sldMkLst>
        <pc:spChg chg="mod">
          <ac:chgData name="Hundley, Heather Ann" userId="9923bbf4-35ca-4515-b4c1-83653bfb90e1" providerId="ADAL" clId="{66347C9E-B753-7C41-9631-0F3A776E72D4}" dt="2023-08-02T14:20:25.801" v="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F21C5D6A-4556-5F79-5335-F655CEC8554D}"/>
    <pc:docChg chg="modSld">
      <pc:chgData name="Salim, Chinnu" userId="S::chisalim@iu.edu::97f0121d-12bb-4de1-b0c3-9497d3c11a4c" providerId="AD" clId="Web-{F21C5D6A-4556-5F79-5335-F655CEC8554D}" dt="2023-08-18T20:17:12.910" v="4" actId="20577"/>
      <pc:docMkLst>
        <pc:docMk/>
      </pc:docMkLst>
      <pc:sldChg chg="modSp">
        <pc:chgData name="Salim, Chinnu" userId="S::chisalim@iu.edu::97f0121d-12bb-4de1-b0c3-9497d3c11a4c" providerId="AD" clId="Web-{F21C5D6A-4556-5F79-5335-F655CEC8554D}" dt="2023-08-18T20:17:12.910" v="4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21C5D6A-4556-5F79-5335-F655CEC8554D}" dt="2023-08-18T20:17:12.910" v="4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clId="Web-{5A9423AA-9140-4B0D-C355-6A50805F2F80}"/>
    <pc:docChg chg="modSld">
      <pc:chgData name="" userId="" providerId="" clId="Web-{5A9423AA-9140-4B0D-C355-6A50805F2F80}" dt="2023-08-17T13:43:54.797" v="1" actId="20577"/>
      <pc:docMkLst>
        <pc:docMk/>
      </pc:docMkLst>
      <pc:sldChg chg="modSp">
        <pc:chgData name="" userId="" providerId="" clId="Web-{5A9423AA-9140-4B0D-C355-6A50805F2F80}" dt="2023-08-17T13:43:54.797" v="1" actId="20577"/>
        <pc:sldMkLst>
          <pc:docMk/>
          <pc:sldMk cId="288543358" sldId="258"/>
        </pc:sldMkLst>
        <pc:spChg chg="mod">
          <ac:chgData name="" userId="" providerId="" clId="Web-{5A9423AA-9140-4B0D-C355-6A50805F2F80}" dt="2023-08-17T13:43:54.797" v="1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5A9423AA-9140-4B0D-C355-6A50805F2F80}"/>
    <pc:docChg chg="modSld">
      <pc:chgData name="Salim, Chinnu" userId="S::chisalim@iu.edu::97f0121d-12bb-4de1-b0c3-9497d3c11a4c" providerId="AD" clId="Web-{5A9423AA-9140-4B0D-C355-6A50805F2F80}" dt="2023-08-17T13:43:59.813" v="1" actId="20577"/>
      <pc:docMkLst>
        <pc:docMk/>
      </pc:docMkLst>
      <pc:sldChg chg="modSp">
        <pc:chgData name="Salim, Chinnu" userId="S::chisalim@iu.edu::97f0121d-12bb-4de1-b0c3-9497d3c11a4c" providerId="AD" clId="Web-{5A9423AA-9140-4B0D-C355-6A50805F2F80}" dt="2023-08-17T13:43:59.813" v="1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9423AA-9140-4B0D-C355-6A50805F2F80}" dt="2023-08-17T13:43:59.813" v="1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Dhakal, Alfa" userId="S::aldhakal@iu.edu::47175381-e0f0-42f2-a909-d585e2a70e98" providerId="AD" clId="Web-{495EAED4-01BC-66CE-EFFB-0EB99CE4AAB0}"/>
    <pc:docChg chg="modSld">
      <pc:chgData name="Dhakal, Alfa" userId="S::aldhakal@iu.edu::47175381-e0f0-42f2-a909-d585e2a70e98" providerId="AD" clId="Web-{495EAED4-01BC-66CE-EFFB-0EB99CE4AAB0}" dt="2023-08-04T18:36:16.751" v="2" actId="20577"/>
      <pc:docMkLst>
        <pc:docMk/>
      </pc:docMkLst>
      <pc:sldChg chg="modSp">
        <pc:chgData name="Dhakal, Alfa" userId="S::aldhakal@iu.edu::47175381-e0f0-42f2-a909-d585e2a70e98" providerId="AD" clId="Web-{495EAED4-01BC-66CE-EFFB-0EB99CE4AAB0}" dt="2023-08-04T18:36:16.751" v="2" actId="20577"/>
        <pc:sldMkLst>
          <pc:docMk/>
          <pc:sldMk cId="288543358" sldId="258"/>
        </pc:sldMkLst>
        <pc:spChg chg="mod">
          <ac:chgData name="Dhakal, Alfa" userId="S::aldhakal@iu.edu::47175381-e0f0-42f2-a909-d585e2a70e98" providerId="AD" clId="Web-{495EAED4-01BC-66CE-EFFB-0EB99CE4AAB0}" dt="2023-08-04T18:36:16.751" v="2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223EA247-C38D-525B-7B73-6BA55854A810}"/>
    <pc:docChg chg="modSld">
      <pc:chgData name="Salim, Chinnu" userId="S::chisalim@iu.edu::97f0121d-12bb-4de1-b0c3-9497d3c11a4c" providerId="AD" clId="Web-{223EA247-C38D-525B-7B73-6BA55854A810}" dt="2024-01-21T19:56:55.745" v="3" actId="20577"/>
      <pc:docMkLst>
        <pc:docMk/>
      </pc:docMkLst>
      <pc:sldChg chg="modSp">
        <pc:chgData name="Salim, Chinnu" userId="S::chisalim@iu.edu::97f0121d-12bb-4de1-b0c3-9497d3c11a4c" providerId="AD" clId="Web-{223EA247-C38D-525B-7B73-6BA55854A810}" dt="2024-01-21T19:56:55.745" v="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223EA247-C38D-525B-7B73-6BA55854A810}" dt="2024-01-21T19:56:55.745" v="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B64A60D3-8F24-715B-3B3A-4CB27282B60C}"/>
    <pc:docChg chg="modSld">
      <pc:chgData name="Salim, Chinnu" userId="S::chisalim@iu.edu::97f0121d-12bb-4de1-b0c3-9497d3c11a4c" providerId="AD" clId="Web-{B64A60D3-8F24-715B-3B3A-4CB27282B60C}" dt="2023-08-17T13:40:34.685" v="1" actId="20577"/>
      <pc:docMkLst>
        <pc:docMk/>
      </pc:docMkLst>
      <pc:sldChg chg="modSp">
        <pc:chgData name="Salim, Chinnu" userId="S::chisalim@iu.edu::97f0121d-12bb-4de1-b0c3-9497d3c11a4c" providerId="AD" clId="Web-{B64A60D3-8F24-715B-3B3A-4CB27282B60C}" dt="2023-08-17T13:40:34.685" v="1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B64A60D3-8F24-715B-3B3A-4CB27282B60C}" dt="2023-08-17T13:40:34.685" v="1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Salim, Chinnu" userId="S::chisalim@iu.edu::97f0121d-12bb-4de1-b0c3-9497d3c11a4c" providerId="AD" clId="Web-{4F82C6E8-661C-0C07-8A38-AFF8163A2AA5}"/>
    <pc:docChg chg="modSld">
      <pc:chgData name="Salim, Chinnu" userId="S::chisalim@iu.edu::97f0121d-12bb-4de1-b0c3-9497d3c11a4c" providerId="AD" clId="Web-{4F82C6E8-661C-0C07-8A38-AFF8163A2AA5}" dt="2023-07-18T04:56:03.957" v="6" actId="20577"/>
      <pc:docMkLst>
        <pc:docMk/>
      </pc:docMkLst>
      <pc:sldChg chg="modSp">
        <pc:chgData name="Salim, Chinnu" userId="S::chisalim@iu.edu::97f0121d-12bb-4de1-b0c3-9497d3c11a4c" providerId="AD" clId="Web-{4F82C6E8-661C-0C07-8A38-AFF8163A2AA5}" dt="2023-07-18T04:56:03.957" v="6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4F82C6E8-661C-0C07-8A38-AFF8163A2AA5}" dt="2023-07-18T04:56:03.957" v="6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4D67A3E-B03D-19D7-7690-E78FEB45FDF3}"/>
              </a:ext>
            </a:extLst>
          </p:cNvPr>
          <p:cNvSpPr txBox="1"/>
          <p:nvPr/>
        </p:nvSpPr>
        <p:spPr>
          <a:xfrm>
            <a:off x="83334" y="2239515"/>
            <a:ext cx="7613364" cy="93871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Additional file 16: Fig. S16. </a:t>
            </a:r>
            <a:r>
              <a:rPr lang="en-US" sz="1100" b="1" dirty="0" err="1">
                <a:latin typeface="Arial"/>
                <a:cs typeface="Arial"/>
              </a:rPr>
              <a:t>qRT</a:t>
            </a:r>
            <a:r>
              <a:rPr lang="en-US" sz="1100" b="1" dirty="0">
                <a:latin typeface="Arial"/>
                <a:cs typeface="Arial"/>
              </a:rPr>
              <a:t>-PCR validation of downregulated collagen genes from RNA-seq analysis. </a:t>
            </a:r>
            <a:r>
              <a:rPr lang="en-US" sz="1100" dirty="0" err="1">
                <a:latin typeface="Arial"/>
                <a:cs typeface="Arial"/>
              </a:rPr>
              <a:t>qRT</a:t>
            </a:r>
            <a:r>
              <a:rPr lang="en-US" sz="1100" dirty="0">
                <a:latin typeface="Arial"/>
                <a:cs typeface="Arial"/>
              </a:rPr>
              <a:t>-PCR quantification of the level of the indicated genes relative to </a:t>
            </a:r>
            <a:r>
              <a:rPr lang="en-US" sz="1100" i="1" dirty="0">
                <a:latin typeface="Arial"/>
                <a:cs typeface="Arial"/>
              </a:rPr>
              <a:t>gpd-3</a:t>
            </a:r>
            <a:r>
              <a:rPr lang="en-US" sz="1100" dirty="0">
                <a:latin typeface="Arial"/>
                <a:cs typeface="Arial"/>
              </a:rPr>
              <a:t> and normalized to the ratios obtained for wildtype (WT). The mean of three biological replicates for each strain was plotted; however, it should be noted the wildtype values used in A, B and C are the same biological replicates. Error bars represent SEM. Statistical significance was determined using a two-way ANOVA Sidak's multiple comparisons test. *</a:t>
            </a:r>
            <a:r>
              <a:rPr lang="en-US" sz="1100" i="1" dirty="0">
                <a:latin typeface="Arial"/>
                <a:cs typeface="Arial"/>
              </a:rPr>
              <a:t>p</a:t>
            </a:r>
            <a:r>
              <a:rPr lang="en-US" sz="1100" dirty="0">
                <a:latin typeface="Arial"/>
                <a:cs typeface="Arial"/>
              </a:rPr>
              <a:t>≤0.05, **</a:t>
            </a:r>
            <a:r>
              <a:rPr lang="en-US" sz="1100" i="1" dirty="0">
                <a:latin typeface="Arial"/>
                <a:cs typeface="Arial"/>
              </a:rPr>
              <a:t>p</a:t>
            </a:r>
            <a:r>
              <a:rPr lang="en-US" sz="1100" dirty="0">
                <a:latin typeface="Arial"/>
                <a:cs typeface="Arial"/>
              </a:rPr>
              <a:t>≤0.005.</a:t>
            </a:r>
            <a:endParaRPr lang="en-US" dirty="0"/>
          </a:p>
        </p:txBody>
      </p:sp>
      <p:pic>
        <p:nvPicPr>
          <p:cNvPr id="8" name="Picture 9" descr="Diagram&#10;&#10;Description automatically generated">
            <a:extLst>
              <a:ext uri="{FF2B5EF4-FFF2-40B4-BE49-F238E27FC236}">
                <a16:creationId xmlns:a16="http://schemas.microsoft.com/office/drawing/2014/main" id="{F3A93107-0411-B9DA-21C7-FC414017B1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2189" y="491140"/>
            <a:ext cx="6008315" cy="1660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543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0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Salim, Chinnu</cp:lastModifiedBy>
  <cp:revision>92</cp:revision>
  <cp:lastPrinted>2023-01-31T14:45:13Z</cp:lastPrinted>
  <dcterms:created xsi:type="dcterms:W3CDTF">2022-10-06T21:20:44Z</dcterms:created>
  <dcterms:modified xsi:type="dcterms:W3CDTF">2024-01-21T19:57:03Z</dcterms:modified>
</cp:coreProperties>
</file>